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224" y="-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E23D3-A11C-4651-88BD-0935158D091A}" type="datetimeFigureOut">
              <a:rPr lang="en-US" smtClean="0"/>
              <a:pPr/>
              <a:t>10/1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639FDE-0C19-4340-90B6-1C9D12A0C2C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 49"/>
          <p:cNvGrpSpPr/>
          <p:nvPr/>
        </p:nvGrpSpPr>
        <p:grpSpPr>
          <a:xfrm>
            <a:off x="1268760" y="1043608"/>
            <a:ext cx="1796270" cy="1668189"/>
            <a:chOff x="692696" y="395536"/>
            <a:chExt cx="1796270" cy="1668189"/>
          </a:xfrm>
        </p:grpSpPr>
        <p:pic>
          <p:nvPicPr>
            <p:cNvPr id="40" name="Picture 39" descr="dot blot methylene blue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268760" y="611560"/>
              <a:ext cx="1080000" cy="1452165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1268760" y="395536"/>
              <a:ext cx="12202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92  384   960ng</a:t>
              </a:r>
              <a:endParaRPr lang="en-US" sz="1200" dirty="0"/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692696" y="641930"/>
              <a:ext cx="675185" cy="1349569"/>
              <a:chOff x="620688" y="641930"/>
              <a:chExt cx="675185" cy="1349569"/>
            </a:xfrm>
          </p:grpSpPr>
          <p:sp>
            <p:nvSpPr>
              <p:cNvPr id="42" name="TextBox 41"/>
              <p:cNvSpPr txBox="1"/>
              <p:nvPr/>
            </p:nvSpPr>
            <p:spPr>
              <a:xfrm>
                <a:off x="620688" y="641930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Ctrl</a:t>
                </a:r>
                <a:endParaRPr lang="en-US" sz="1200" dirty="0"/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620688" y="1714500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µM</a:t>
                </a:r>
                <a:endParaRPr lang="en-US" sz="12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620688" y="1358900"/>
                <a:ext cx="67518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0.75µM</a:t>
                </a:r>
                <a:endParaRPr lang="en-US" sz="12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620688" y="1015950"/>
                <a:ext cx="5966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0.5µM</a:t>
                </a:r>
                <a:endParaRPr lang="en-US" sz="1200" dirty="0"/>
              </a:p>
            </p:txBody>
          </p:sp>
        </p:grpSp>
      </p:grpSp>
      <p:sp>
        <p:nvSpPr>
          <p:cNvPr id="51" name="TextBox 50"/>
          <p:cNvSpPr txBox="1"/>
          <p:nvPr/>
        </p:nvSpPr>
        <p:spPr>
          <a:xfrm>
            <a:off x="332656" y="395536"/>
            <a:ext cx="1818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upplemental Figure 1</a:t>
            </a:r>
            <a:endParaRPr lang="en-US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1268760" y="102386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</a:t>
            </a:r>
            <a:endParaRPr lang="en-US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-figure2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08720" y="1115616"/>
            <a:ext cx="4716000" cy="4652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32656" y="395536"/>
            <a:ext cx="1818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upplemental Figure 2</a:t>
            </a:r>
            <a:endParaRPr lang="en-US" sz="14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emental figure 3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48680" y="611560"/>
            <a:ext cx="5436000" cy="80337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32656" y="323528"/>
            <a:ext cx="1818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upplemental Figure </a:t>
            </a:r>
            <a:r>
              <a:rPr lang="en-US" sz="1400" dirty="0" smtClean="0"/>
              <a:t>3</a:t>
            </a:r>
            <a:endParaRPr 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</TotalTime>
  <Words>17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Emory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ekunLi</dc:creator>
  <cp:lastModifiedBy>XuekunLi</cp:lastModifiedBy>
  <cp:revision>31</cp:revision>
  <dcterms:created xsi:type="dcterms:W3CDTF">2015-10-02T01:34:59Z</dcterms:created>
  <dcterms:modified xsi:type="dcterms:W3CDTF">2015-10-13T02:12:35Z</dcterms:modified>
</cp:coreProperties>
</file>